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363" r:id="rId2"/>
  </p:sldIdLst>
  <p:sldSz cx="18000663" cy="14400213"/>
  <p:notesSz cx="9926638" cy="6797675"/>
  <p:defaultTextStyle>
    <a:defPPr>
      <a:defRPr lang="ko-KR"/>
    </a:defPPr>
    <a:lvl1pPr marL="0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1pPr>
    <a:lvl2pPr marL="925739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2pPr>
    <a:lvl3pPr marL="1851477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3pPr>
    <a:lvl4pPr marL="2777216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4pPr>
    <a:lvl5pPr marL="3702954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5pPr>
    <a:lvl6pPr marL="4628693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6pPr>
    <a:lvl7pPr marL="5554431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7pPr>
    <a:lvl8pPr marL="6480170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8pPr>
    <a:lvl9pPr marL="7405908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81" userDrawn="1">
          <p15:clr>
            <a:srgbClr val="A4A3A4"/>
          </p15:clr>
        </p15:guide>
        <p15:guide id="2" pos="55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70B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9" autoAdjust="0"/>
    <p:restoredTop sz="93343" autoAdjust="0"/>
  </p:normalViewPr>
  <p:slideViewPr>
    <p:cSldViewPr snapToGrid="0" showGuides="1">
      <p:cViewPr varScale="1">
        <p:scale>
          <a:sx n="28" d="100"/>
          <a:sy n="28" d="100"/>
        </p:scale>
        <p:origin x="1260" y="32"/>
      </p:cViewPr>
      <p:guideLst>
        <p:guide orient="horz" pos="4581"/>
        <p:guide pos="55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0E09C-C9D3-4408-B620-F75D631D088D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5A743C-867F-4480-AECF-618A25AA57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31618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B5825F-D85D-4232-A0B4-E6911F1B9680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530600" y="850900"/>
            <a:ext cx="2865438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2665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08B7D4-F36D-4BC6-B6E1-5F8F71F39BA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33300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1pPr>
    <a:lvl2pPr marL="925739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2pPr>
    <a:lvl3pPr marL="1851477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3pPr>
    <a:lvl4pPr marL="2777216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4pPr>
    <a:lvl5pPr marL="3702954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5pPr>
    <a:lvl6pPr marL="4628693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6pPr>
    <a:lvl7pPr marL="5554431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7pPr>
    <a:lvl8pPr marL="6480170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8pPr>
    <a:lvl9pPr marL="7405908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3530600" y="850900"/>
            <a:ext cx="2865438" cy="229235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52EB02-0B94-4A9E-8A9B-2C27456C27D4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58019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8695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0740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7307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477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0235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5213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588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9218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110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3268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5939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064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1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1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emf"/><Relationship Id="rId21" Type="http://schemas.openxmlformats.org/officeDocument/2006/relationships/image" Target="../media/image19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5" Type="http://schemas.openxmlformats.org/officeDocument/2006/relationships/image" Target="../media/image23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직사각형 42"/>
          <p:cNvSpPr/>
          <p:nvPr/>
        </p:nvSpPr>
        <p:spPr>
          <a:xfrm>
            <a:off x="814374" y="1104900"/>
            <a:ext cx="8308361" cy="7483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4725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altLang="ko-KR" sz="472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4725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4725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644307" y="2155166"/>
            <a:ext cx="4587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200" dirty="0">
                <a:latin typeface="Arial"/>
                <a:ea typeface="Arial" charset="0"/>
                <a:cs typeface="Arial"/>
              </a:rPr>
              <a:t>A</a:t>
            </a:r>
            <a:endParaRPr lang="ko-KR" altLang="en-US" sz="32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7963076" y="2155166"/>
            <a:ext cx="4587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200" dirty="0" smtClean="0">
                <a:latin typeface="Arial"/>
                <a:ea typeface="Arial" charset="0"/>
                <a:cs typeface="Arial"/>
              </a:rPr>
              <a:t>B</a:t>
            </a:r>
            <a:endParaRPr lang="ko-KR" altLang="en-US" sz="3200" dirty="0">
              <a:latin typeface="Arial"/>
              <a:ea typeface="Arial" charset="0"/>
              <a:cs typeface="Arial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8379860" y="2850956"/>
            <a:ext cx="7051896" cy="7072827"/>
            <a:chOff x="8379860" y="2850956"/>
            <a:chExt cx="7051896" cy="7072827"/>
          </a:xfrm>
        </p:grpSpPr>
        <p:pic>
          <p:nvPicPr>
            <p:cNvPr id="85" name="그림 84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379860" y="3522585"/>
              <a:ext cx="1619999" cy="1601999"/>
            </a:xfrm>
            <a:prstGeom prst="rect">
              <a:avLst/>
            </a:prstGeom>
          </p:spPr>
        </p:pic>
        <p:sp>
          <p:nvSpPr>
            <p:cNvPr id="86" name="TextBox 85"/>
            <p:cNvSpPr txBox="1"/>
            <p:nvPr/>
          </p:nvSpPr>
          <p:spPr>
            <a:xfrm>
              <a:off x="8780194" y="4088398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4.66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7" name="그림 86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624655" y="3522585"/>
              <a:ext cx="1619999" cy="1601999"/>
            </a:xfrm>
            <a:prstGeom prst="rect">
              <a:avLst/>
            </a:prstGeom>
          </p:spPr>
        </p:pic>
        <p:pic>
          <p:nvPicPr>
            <p:cNvPr id="88" name="그림 87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624655" y="5030429"/>
              <a:ext cx="1619999" cy="1601999"/>
            </a:xfrm>
            <a:prstGeom prst="rect">
              <a:avLst/>
            </a:prstGeom>
          </p:spPr>
        </p:pic>
        <p:sp>
          <p:nvSpPr>
            <p:cNvPr id="89" name="Rectangle 6"/>
            <p:cNvSpPr>
              <a:spLocks noChangeArrowheads="1"/>
            </p:cNvSpPr>
            <p:nvPr/>
          </p:nvSpPr>
          <p:spPr bwMode="auto">
            <a:xfrm rot="10800000" flipV="1">
              <a:off x="11910441" y="3300364"/>
              <a:ext cx="1273265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/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UC-MSC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0" name="그림 89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624655" y="6538273"/>
              <a:ext cx="1619999" cy="1601999"/>
            </a:xfrm>
            <a:prstGeom prst="rect">
              <a:avLst/>
            </a:prstGeom>
          </p:spPr>
        </p:pic>
        <p:sp>
          <p:nvSpPr>
            <p:cNvPr id="91" name="TextBox 90"/>
            <p:cNvSpPr txBox="1"/>
            <p:nvPr/>
          </p:nvSpPr>
          <p:spPr>
            <a:xfrm>
              <a:off x="12152626" y="4088398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.27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2051026" y="5588242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.82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2037866" y="7225451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.96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4" name="그림 93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002258" y="3522585"/>
              <a:ext cx="1619999" cy="1601999"/>
            </a:xfrm>
            <a:prstGeom prst="rect">
              <a:avLst/>
            </a:prstGeom>
          </p:spPr>
        </p:pic>
        <p:pic>
          <p:nvPicPr>
            <p:cNvPr id="95" name="그림 94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002258" y="5030429"/>
              <a:ext cx="1619999" cy="1601999"/>
            </a:xfrm>
            <a:prstGeom prst="rect">
              <a:avLst/>
            </a:prstGeom>
          </p:spPr>
        </p:pic>
        <p:sp>
          <p:nvSpPr>
            <p:cNvPr id="96" name="Rectangle 6"/>
            <p:cNvSpPr>
              <a:spLocks noChangeArrowheads="1"/>
            </p:cNvSpPr>
            <p:nvPr/>
          </p:nvSpPr>
          <p:spPr bwMode="auto">
            <a:xfrm rot="10800000" flipV="1">
              <a:off x="10353800" y="3300364"/>
              <a:ext cx="1183402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/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PDLSC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7" name="그림 96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002258" y="6538273"/>
              <a:ext cx="1619999" cy="1601999"/>
            </a:xfrm>
            <a:prstGeom prst="rect">
              <a:avLst/>
            </a:prstGeom>
          </p:spPr>
        </p:pic>
        <p:sp>
          <p:nvSpPr>
            <p:cNvPr id="98" name="TextBox 97"/>
            <p:cNvSpPr txBox="1"/>
            <p:nvPr/>
          </p:nvSpPr>
          <p:spPr>
            <a:xfrm>
              <a:off x="10497996" y="4088398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.79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10396396" y="5588242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.38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10383236" y="7229854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.07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1" name="그림 100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247053" y="3522585"/>
              <a:ext cx="1619999" cy="1601999"/>
            </a:xfrm>
            <a:prstGeom prst="rect">
              <a:avLst/>
            </a:prstGeom>
          </p:spPr>
        </p:pic>
        <p:pic>
          <p:nvPicPr>
            <p:cNvPr id="102" name="그림 101"/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3247053" y="5030429"/>
              <a:ext cx="1619999" cy="1601999"/>
            </a:xfrm>
            <a:prstGeom prst="rect">
              <a:avLst/>
            </a:prstGeom>
          </p:spPr>
        </p:pic>
        <p:pic>
          <p:nvPicPr>
            <p:cNvPr id="103" name="그림 102"/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3247053" y="6538273"/>
              <a:ext cx="1619999" cy="1602000"/>
            </a:xfrm>
            <a:prstGeom prst="rect">
              <a:avLst/>
            </a:prstGeom>
          </p:spPr>
        </p:pic>
        <p:sp>
          <p:nvSpPr>
            <p:cNvPr id="104" name="Rectangle 6"/>
            <p:cNvSpPr>
              <a:spLocks noChangeArrowheads="1"/>
            </p:cNvSpPr>
            <p:nvPr/>
          </p:nvSpPr>
          <p:spPr bwMode="auto">
            <a:xfrm rot="10800000" flipV="1">
              <a:off x="13474648" y="3300364"/>
              <a:ext cx="1310108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/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AD-MSC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6"/>
            <p:cNvSpPr>
              <a:spLocks noChangeArrowheads="1"/>
            </p:cNvSpPr>
            <p:nvPr/>
          </p:nvSpPr>
          <p:spPr bwMode="auto">
            <a:xfrm rot="5400000" flipV="1">
              <a:off x="14390915" y="5682058"/>
              <a:ext cx="1281463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/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NS398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angle 6"/>
            <p:cNvSpPr>
              <a:spLocks noChangeArrowheads="1"/>
            </p:cNvSpPr>
            <p:nvPr/>
          </p:nvSpPr>
          <p:spPr bwMode="auto">
            <a:xfrm rot="5400000" flipV="1">
              <a:off x="14515153" y="7188891"/>
              <a:ext cx="1032987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/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1-MT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Rectangle 6"/>
            <p:cNvSpPr>
              <a:spLocks noChangeArrowheads="1"/>
            </p:cNvSpPr>
            <p:nvPr/>
          </p:nvSpPr>
          <p:spPr bwMode="auto">
            <a:xfrm rot="5400000" flipV="1">
              <a:off x="14390915" y="4087451"/>
              <a:ext cx="1281463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/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DMSO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13810361" y="4088398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.00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13708761" y="5588242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.57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3695601" y="7198355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.95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직사각형 110"/>
            <p:cNvSpPr/>
            <p:nvPr/>
          </p:nvSpPr>
          <p:spPr>
            <a:xfrm>
              <a:off x="10893026" y="2850956"/>
              <a:ext cx="1718812" cy="3075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C:PBMC</a:t>
              </a:r>
              <a:endParaRPr lang="ko-KR" alt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직선 연결선 111"/>
            <p:cNvCxnSpPr/>
            <p:nvPr/>
          </p:nvCxnSpPr>
          <p:spPr>
            <a:xfrm flipV="1">
              <a:off x="8703773" y="3214081"/>
              <a:ext cx="59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Rectangle 6"/>
            <p:cNvSpPr>
              <a:spLocks noChangeArrowheads="1"/>
            </p:cNvSpPr>
            <p:nvPr/>
          </p:nvSpPr>
          <p:spPr bwMode="auto">
            <a:xfrm rot="10800000" flipV="1">
              <a:off x="8656355" y="3300363"/>
              <a:ext cx="1324206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/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/o MSC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12091068" y="5616817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.82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10436438" y="5616817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.38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13748803" y="5616817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.57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직사각형 116"/>
            <p:cNvSpPr/>
            <p:nvPr/>
          </p:nvSpPr>
          <p:spPr>
            <a:xfrm>
              <a:off x="10441799" y="6497765"/>
              <a:ext cx="4161505" cy="144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직사각형 117"/>
            <p:cNvSpPr/>
            <p:nvPr/>
          </p:nvSpPr>
          <p:spPr>
            <a:xfrm>
              <a:off x="8761130" y="5019773"/>
              <a:ext cx="5785365" cy="10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직사각형 118"/>
            <p:cNvSpPr/>
            <p:nvPr/>
          </p:nvSpPr>
          <p:spPr>
            <a:xfrm>
              <a:off x="10290577" y="8065671"/>
              <a:ext cx="4161505" cy="144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Rectangle 6"/>
            <p:cNvSpPr>
              <a:spLocks noChangeArrowheads="1"/>
            </p:cNvSpPr>
            <p:nvPr/>
          </p:nvSpPr>
          <p:spPr bwMode="auto">
            <a:xfrm>
              <a:off x="13981053" y="9641014"/>
              <a:ext cx="621513" cy="28276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latinLnBrk="0"/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CFSE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1" name="Straight Arrow Connector 2"/>
            <p:cNvCxnSpPr/>
            <p:nvPr/>
          </p:nvCxnSpPr>
          <p:spPr bwMode="auto">
            <a:xfrm>
              <a:off x="10281697" y="9786836"/>
              <a:ext cx="3636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med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Rectangle 6"/>
            <p:cNvSpPr>
              <a:spLocks noChangeArrowheads="1"/>
            </p:cNvSpPr>
            <p:nvPr/>
          </p:nvSpPr>
          <p:spPr bwMode="auto">
            <a:xfrm rot="5400000" flipV="1">
              <a:off x="14614904" y="8596716"/>
              <a:ext cx="1141261" cy="4924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/>
            <a:p>
              <a:pPr algn="ctr" latinLnBrk="0">
                <a:lnSpc>
                  <a:spcPct val="80000"/>
                </a:lnSpc>
              </a:pPr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NS-398</a:t>
              </a:r>
            </a:p>
            <a:p>
              <a:pPr algn="ctr" latinLnBrk="0">
                <a:lnSpc>
                  <a:spcPct val="80000"/>
                </a:lnSpc>
              </a:pPr>
              <a:r>
                <a:rPr lang="en-US" altLang="ko-K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&amp; 1-MT</a:t>
              </a:r>
              <a:endParaRPr lang="ko-KR" altLang="ko-KR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직사각형 128"/>
            <p:cNvSpPr/>
            <p:nvPr/>
          </p:nvSpPr>
          <p:spPr>
            <a:xfrm>
              <a:off x="10530699" y="8034465"/>
              <a:ext cx="4161505" cy="144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직사각형 129"/>
            <p:cNvSpPr/>
            <p:nvPr/>
          </p:nvSpPr>
          <p:spPr>
            <a:xfrm>
              <a:off x="10315707" y="8000686"/>
              <a:ext cx="4161505" cy="144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2" name="그림 131"/>
            <p:cNvPicPr preferRelativeResize="0"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0002258" y="8046117"/>
              <a:ext cx="1620000" cy="1602000"/>
            </a:xfrm>
            <a:prstGeom prst="rect">
              <a:avLst/>
            </a:prstGeom>
          </p:spPr>
        </p:pic>
        <p:pic>
          <p:nvPicPr>
            <p:cNvPr id="133" name="그림 132"/>
            <p:cNvPicPr preferRelativeResize="0"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1624655" y="8046117"/>
              <a:ext cx="1620000" cy="1602000"/>
            </a:xfrm>
            <a:prstGeom prst="rect">
              <a:avLst/>
            </a:prstGeom>
          </p:spPr>
        </p:pic>
        <p:pic>
          <p:nvPicPr>
            <p:cNvPr id="134" name="그림 133"/>
            <p:cNvPicPr preferRelativeResize="0">
              <a:picLocks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3247053" y="8046117"/>
              <a:ext cx="1620000" cy="1602000"/>
            </a:xfrm>
            <a:prstGeom prst="rect">
              <a:avLst/>
            </a:prstGeom>
          </p:spPr>
        </p:pic>
        <p:sp>
          <p:nvSpPr>
            <p:cNvPr id="135" name="TextBox 134"/>
            <p:cNvSpPr txBox="1"/>
            <p:nvPr/>
          </p:nvSpPr>
          <p:spPr>
            <a:xfrm>
              <a:off x="12052493" y="8535758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3.18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0421525" y="8506586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.15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3703875" y="8464816"/>
              <a:ext cx="79220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.83%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직사각형 137"/>
            <p:cNvSpPr/>
            <p:nvPr/>
          </p:nvSpPr>
          <p:spPr>
            <a:xfrm>
              <a:off x="10546304" y="7988530"/>
              <a:ext cx="4161505" cy="144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39" name="그림 13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915913" y="5047087"/>
            <a:ext cx="1598431" cy="1620000"/>
          </a:xfrm>
          <a:prstGeom prst="rect">
            <a:avLst/>
          </a:prstGeom>
        </p:spPr>
      </p:pic>
      <p:pic>
        <p:nvPicPr>
          <p:cNvPr id="140" name="그림 139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769751" y="6571589"/>
            <a:ext cx="1598431" cy="1620000"/>
          </a:xfrm>
          <a:prstGeom prst="rect">
            <a:avLst/>
          </a:prstGeom>
        </p:spPr>
      </p:pic>
      <p:pic>
        <p:nvPicPr>
          <p:cNvPr id="141" name="그림 140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342832" y="6571589"/>
            <a:ext cx="1598431" cy="1620000"/>
          </a:xfrm>
          <a:prstGeom prst="rect">
            <a:avLst/>
          </a:prstGeom>
        </p:spPr>
      </p:pic>
      <p:pic>
        <p:nvPicPr>
          <p:cNvPr id="142" name="그림 14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915913" y="6571589"/>
            <a:ext cx="1598431" cy="1620000"/>
          </a:xfrm>
          <a:prstGeom prst="rect">
            <a:avLst/>
          </a:prstGeom>
        </p:spPr>
      </p:pic>
      <p:pic>
        <p:nvPicPr>
          <p:cNvPr id="128" name="그림 127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769751" y="5030429"/>
            <a:ext cx="1598431" cy="1620000"/>
          </a:xfrm>
          <a:prstGeom prst="rect">
            <a:avLst/>
          </a:prstGeom>
        </p:spPr>
      </p:pic>
      <p:pic>
        <p:nvPicPr>
          <p:cNvPr id="131" name="그림 130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342832" y="5030429"/>
            <a:ext cx="1598431" cy="1620000"/>
          </a:xfrm>
          <a:prstGeom prst="rect">
            <a:avLst/>
          </a:prstGeom>
        </p:spPr>
      </p:pic>
      <p:pic>
        <p:nvPicPr>
          <p:cNvPr id="122" name="그림 121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196670" y="3522585"/>
            <a:ext cx="1598431" cy="1620000"/>
          </a:xfrm>
          <a:prstGeom prst="rect">
            <a:avLst/>
          </a:prstGeom>
        </p:spPr>
      </p:pic>
      <p:pic>
        <p:nvPicPr>
          <p:cNvPr id="123" name="그림 122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769751" y="3522585"/>
            <a:ext cx="1598431" cy="1620000"/>
          </a:xfrm>
          <a:prstGeom prst="rect">
            <a:avLst/>
          </a:prstGeom>
        </p:spPr>
      </p:pic>
      <p:pic>
        <p:nvPicPr>
          <p:cNvPr id="124" name="그림 123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342832" y="3522585"/>
            <a:ext cx="1598431" cy="1620000"/>
          </a:xfrm>
          <a:prstGeom prst="rect">
            <a:avLst/>
          </a:prstGeom>
        </p:spPr>
      </p:pic>
      <p:pic>
        <p:nvPicPr>
          <p:cNvPr id="126" name="그림 125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915913" y="3522585"/>
            <a:ext cx="1598431" cy="1620000"/>
          </a:xfrm>
          <a:prstGeom prst="rect">
            <a:avLst/>
          </a:prstGeom>
        </p:spPr>
      </p:pic>
      <p:sp>
        <p:nvSpPr>
          <p:cNvPr id="19" name="직사각형 18"/>
          <p:cNvSpPr/>
          <p:nvPr/>
        </p:nvSpPr>
        <p:spPr>
          <a:xfrm>
            <a:off x="3741153" y="2862420"/>
            <a:ext cx="1718812" cy="3075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:PBMC</a:t>
            </a:r>
            <a:endParaRPr lang="ko-KR" altLang="en-US" sz="2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115899" y="5544289"/>
            <a:ext cx="717645" cy="28276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39.31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667760" y="5544289"/>
            <a:ext cx="717645" cy="28276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52.00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206624" y="5544289"/>
            <a:ext cx="717645" cy="28276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82.53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6"/>
          <p:cNvSpPr>
            <a:spLocks noChangeArrowheads="1"/>
          </p:cNvSpPr>
          <p:nvPr/>
        </p:nvSpPr>
        <p:spPr bwMode="auto">
          <a:xfrm rot="16200000">
            <a:off x="7035000" y="5576247"/>
            <a:ext cx="124442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 lIns="0" tIns="0" rIns="0" bIns="0">
            <a:spAutoFit/>
          </a:bodyPr>
          <a:lstStyle/>
          <a:p>
            <a:pPr algn="ctr" latinLnBrk="0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UC-MSC</a:t>
            </a:r>
            <a:endParaRPr lang="ko-KR" altLang="ko-K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Arrow Connector 2"/>
          <p:cNvCxnSpPr/>
          <p:nvPr/>
        </p:nvCxnSpPr>
        <p:spPr bwMode="auto">
          <a:xfrm>
            <a:off x="3058753" y="8241949"/>
            <a:ext cx="3600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120653" y="4051776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.74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736112" y="4051776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52.57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317783" y="4051776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2.16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6"/>
          <p:cNvSpPr>
            <a:spLocks noChangeArrowheads="1"/>
          </p:cNvSpPr>
          <p:nvPr/>
        </p:nvSpPr>
        <p:spPr bwMode="auto">
          <a:xfrm rot="16200000">
            <a:off x="7146073" y="4075266"/>
            <a:ext cx="993309" cy="278810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 lIns="0" tIns="0" rIns="0" bIns="0">
            <a:spAutoFit/>
          </a:bodyPr>
          <a:lstStyle/>
          <a:p>
            <a:pPr algn="ctr" latinLnBrk="0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PDLSC</a:t>
            </a:r>
            <a:endParaRPr lang="ko-KR" altLang="ko-K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115899" y="7089830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0.65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667760" y="7089830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9.40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206624" y="7089830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88.64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6"/>
          <p:cNvSpPr>
            <a:spLocks noChangeArrowheads="1"/>
          </p:cNvSpPr>
          <p:nvPr/>
        </p:nvSpPr>
        <p:spPr bwMode="auto">
          <a:xfrm rot="16200000">
            <a:off x="7155090" y="7115510"/>
            <a:ext cx="103013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 lIns="0" tIns="0" rIns="0" bIns="0">
            <a:spAutoFit/>
          </a:bodyPr>
          <a:lstStyle/>
          <a:p>
            <a:pPr algn="ctr" latinLnBrk="0"/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D-MSC</a:t>
            </a:r>
            <a:endParaRPr lang="ko-KR" altLang="ko-K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3211339" y="8048376"/>
            <a:ext cx="4161505" cy="1282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직사각형 384"/>
          <p:cNvSpPr/>
          <p:nvPr/>
        </p:nvSpPr>
        <p:spPr>
          <a:xfrm>
            <a:off x="3264896" y="3300567"/>
            <a:ext cx="922127" cy="3075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 25</a:t>
            </a:r>
            <a:endParaRPr lang="ko-KR" altLang="en-US" sz="2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직사각형 385"/>
          <p:cNvSpPr/>
          <p:nvPr/>
        </p:nvSpPr>
        <p:spPr>
          <a:xfrm>
            <a:off x="4809818" y="3300567"/>
            <a:ext cx="922127" cy="3075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 100</a:t>
            </a:r>
            <a:endParaRPr lang="ko-KR" altLang="en-US" sz="2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직사각형 386"/>
          <p:cNvSpPr/>
          <p:nvPr/>
        </p:nvSpPr>
        <p:spPr>
          <a:xfrm>
            <a:off x="6320947" y="3300567"/>
            <a:ext cx="922127" cy="3075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 400</a:t>
            </a:r>
            <a:endParaRPr lang="ko-KR" altLang="en-US" sz="2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5" name="직선 연결선 424"/>
          <p:cNvCxnSpPr/>
          <p:nvPr/>
        </p:nvCxnSpPr>
        <p:spPr>
          <a:xfrm flipV="1">
            <a:off x="1513800" y="3225545"/>
            <a:ext cx="59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7" name="직사각형 426"/>
          <p:cNvSpPr/>
          <p:nvPr/>
        </p:nvSpPr>
        <p:spPr>
          <a:xfrm>
            <a:off x="1503382" y="3301070"/>
            <a:ext cx="1223730" cy="30707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/o MSC</a:t>
            </a:r>
            <a:endParaRPr lang="ko-KR" altLang="en-US" sz="2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5" name="TextBox 1334"/>
          <p:cNvSpPr txBox="1"/>
          <p:nvPr/>
        </p:nvSpPr>
        <p:spPr>
          <a:xfrm>
            <a:off x="3155941" y="5569297"/>
            <a:ext cx="717645" cy="28276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39.31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6" name="TextBox 1335"/>
          <p:cNvSpPr txBox="1"/>
          <p:nvPr/>
        </p:nvSpPr>
        <p:spPr>
          <a:xfrm>
            <a:off x="4707802" y="5544289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2.08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7" name="TextBox 1336"/>
          <p:cNvSpPr txBox="1"/>
          <p:nvPr/>
        </p:nvSpPr>
        <p:spPr>
          <a:xfrm>
            <a:off x="6246666" y="5544289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7.53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8" name="직사각형 1337"/>
          <p:cNvSpPr/>
          <p:nvPr/>
        </p:nvSpPr>
        <p:spPr>
          <a:xfrm>
            <a:off x="3198773" y="6542384"/>
            <a:ext cx="4144215" cy="1275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2" name="직사각형 1341"/>
          <p:cNvSpPr/>
          <p:nvPr/>
        </p:nvSpPr>
        <p:spPr>
          <a:xfrm>
            <a:off x="1513800" y="5002507"/>
            <a:ext cx="5785365" cy="10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499588" y="4051776"/>
            <a:ext cx="7922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4.40%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6"/>
          <p:cNvSpPr>
            <a:spLocks noChangeArrowheads="1"/>
          </p:cNvSpPr>
          <p:nvPr/>
        </p:nvSpPr>
        <p:spPr bwMode="auto">
          <a:xfrm>
            <a:off x="6753793" y="8088444"/>
            <a:ext cx="621513" cy="28276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latinLnBrk="0"/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ko-KR" altLang="ko-K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3524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692</TotalTime>
  <Words>102</Words>
  <Application>Microsoft Office PowerPoint</Application>
  <PresentationFormat>사용자 지정</PresentationFormat>
  <Paragraphs>5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진희</dc:creator>
  <cp:lastModifiedBy>황영일</cp:lastModifiedBy>
  <cp:revision>558</cp:revision>
  <cp:lastPrinted>2017-06-10T01:06:02Z</cp:lastPrinted>
  <dcterms:created xsi:type="dcterms:W3CDTF">2016-08-07T03:25:07Z</dcterms:created>
  <dcterms:modified xsi:type="dcterms:W3CDTF">2018-01-02T08:43:14Z</dcterms:modified>
</cp:coreProperties>
</file>